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8" y="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121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949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536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432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555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357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273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5429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335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59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159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BEE0D-0AC9-4D95-8984-106A63109AF5}" type="datetimeFigureOut">
              <a:rPr lang="en-US" smtClean="0"/>
              <a:t>9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83C13-A3FB-42D1-AC8A-CB6821349B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675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6386" y="362353"/>
            <a:ext cx="10742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figure 3. 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20 extra pulmonary sarcoidosis subjects were classified into 4 subgroups based on hierarchical cluster analysis, the optimal number of clusters by a hierarchical cluster analysis was determined by k-means clustering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3476" y="919421"/>
            <a:ext cx="4991100" cy="5153025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 flipH="1">
            <a:off x="3114828" y="2444774"/>
            <a:ext cx="9428" cy="3994554"/>
          </a:xfrm>
          <a:prstGeom prst="line">
            <a:avLst/>
          </a:prstGeom>
          <a:ln w="19050">
            <a:solidFill>
              <a:srgbClr val="5236F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>
            <a:off x="3665714" y="2444774"/>
            <a:ext cx="9428" cy="3994554"/>
          </a:xfrm>
          <a:prstGeom prst="line">
            <a:avLst/>
          </a:prstGeom>
          <a:ln w="19050">
            <a:solidFill>
              <a:srgbClr val="5236F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>
            <a:off x="4674205" y="2444774"/>
            <a:ext cx="9428" cy="3994554"/>
          </a:xfrm>
          <a:prstGeom prst="line">
            <a:avLst/>
          </a:prstGeom>
          <a:ln w="19050">
            <a:solidFill>
              <a:srgbClr val="5236F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>
            <a:off x="6400800" y="2444774"/>
            <a:ext cx="9428" cy="3994554"/>
          </a:xfrm>
          <a:prstGeom prst="line">
            <a:avLst/>
          </a:prstGeom>
          <a:ln w="19050">
            <a:solidFill>
              <a:srgbClr val="5236F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7718141" y="2444774"/>
            <a:ext cx="9428" cy="3994554"/>
          </a:xfrm>
          <a:prstGeom prst="line">
            <a:avLst/>
          </a:prstGeom>
          <a:ln w="19050">
            <a:solidFill>
              <a:srgbClr val="5236F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873476" y="6066926"/>
            <a:ext cx="50643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14                32                               40                                  34</a:t>
            </a:r>
          </a:p>
        </p:txBody>
      </p:sp>
    </p:spTree>
    <p:extLst>
      <p:ext uri="{BB962C8B-B14F-4D97-AF65-F5344CB8AC3E}">
        <p14:creationId xmlns:p14="http://schemas.microsoft.com/office/powerpoint/2010/main" val="219385217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zeh, Nabeel Y</dc:creator>
  <cp:lastModifiedBy>Hamzeh, Nabeel Y</cp:lastModifiedBy>
  <cp:revision>1</cp:revision>
  <dcterms:created xsi:type="dcterms:W3CDTF">2022-09-27T14:06:00Z</dcterms:created>
  <dcterms:modified xsi:type="dcterms:W3CDTF">2022-09-27T14:06:23Z</dcterms:modified>
</cp:coreProperties>
</file>